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ichard Truman" initials="RT" lastIdx="1" clrIdx="0">
    <p:extLst>
      <p:ext uri="{19B8F6BF-5375-455C-9EA6-DF929625EA0E}">
        <p15:presenceInfo xmlns:p15="http://schemas.microsoft.com/office/powerpoint/2012/main" userId="51c77448dc93edf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9" autoAdjust="0"/>
    <p:restoredTop sz="94660"/>
  </p:normalViewPr>
  <p:slideViewPr>
    <p:cSldViewPr>
      <p:cViewPr varScale="1">
        <p:scale>
          <a:sx n="73" d="100"/>
          <a:sy n="73" d="100"/>
        </p:scale>
        <p:origin x="111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14" Type="http://schemas.microsoft.com/office/2015/10/relationships/revisionInfo" Target="revisionInfo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95356E-3BD2-4CA7-9E93-8BD11EDE343F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DE05C1-517A-4580-B725-AF9DEA72F1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6079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6387" name="Notes Placeholder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/>
            <a:endParaRPr lang="en-US"/>
          </a:p>
        </p:txBody>
      </p:sp>
      <p:sp>
        <p:nvSpPr>
          <p:cNvPr id="16388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43402FD6-9197-47BA-865E-22441B7840E7}" type="slidenum">
              <a:rPr lang="en-US" smtClean="0"/>
              <a:pPr eaLnBrk="1" hangingPunct="1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9850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8FA66-C0E0-4D03-A6C5-F34EAC04F8B4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ECA2C-A072-4005-978B-ADD62F58BC1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8FA66-C0E0-4D03-A6C5-F34EAC04F8B4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ECA2C-A072-4005-978B-ADD62F58BC1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8FA66-C0E0-4D03-A6C5-F34EAC04F8B4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ECA2C-A072-4005-978B-ADD62F58BC1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8FA66-C0E0-4D03-A6C5-F34EAC04F8B4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ECA2C-A072-4005-978B-ADD62F58BC1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8FA66-C0E0-4D03-A6C5-F34EAC04F8B4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ECA2C-A072-4005-978B-ADD62F58BC1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8FA66-C0E0-4D03-A6C5-F34EAC04F8B4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ECA2C-A072-4005-978B-ADD62F58BC1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8FA66-C0E0-4D03-A6C5-F34EAC04F8B4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ECA2C-A072-4005-978B-ADD62F58BC1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8FA66-C0E0-4D03-A6C5-F34EAC04F8B4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ECA2C-A072-4005-978B-ADD62F58BC1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8FA66-C0E0-4D03-A6C5-F34EAC04F8B4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ECA2C-A072-4005-978B-ADD62F58BC1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8FA66-C0E0-4D03-A6C5-F34EAC04F8B4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ECA2C-A072-4005-978B-ADD62F58BC1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8FA66-C0E0-4D03-A6C5-F34EAC04F8B4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ECA2C-A072-4005-978B-ADD62F58BC1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A8FA66-C0E0-4D03-A6C5-F34EAC04F8B4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DECA2C-A072-4005-978B-ADD62F58BC1E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 Box 13"/>
          <p:cNvSpPr txBox="1">
            <a:spLocks noChangeArrowheads="1"/>
          </p:cNvSpPr>
          <p:nvPr/>
        </p:nvSpPr>
        <p:spPr bwMode="auto">
          <a:xfrm>
            <a:off x="0" y="0"/>
            <a:ext cx="373380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dirty="0"/>
              <a:t>Duthie, </a:t>
            </a:r>
            <a:r>
              <a:rPr lang="en-US" dirty="0" smtClean="0"/>
              <a:t>Supplemental Figure 1</a:t>
            </a:r>
            <a:endParaRPr lang="en-US" dirty="0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1805915"/>
              </p:ext>
            </p:extLst>
          </p:nvPr>
        </p:nvGraphicFramePr>
        <p:xfrm>
          <a:off x="3168650" y="762000"/>
          <a:ext cx="1860550" cy="3402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40" name="Prism 7" r:id="rId4" imgW="2503303" imgH="4576838" progId="Prism7.Document">
                  <p:embed/>
                </p:oleObj>
              </mc:Choice>
              <mc:Fallback>
                <p:oleObj name="Prism 7" r:id="rId4" imgW="2503303" imgH="457683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168650" y="762000"/>
                        <a:ext cx="1860550" cy="3402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4419600" y="2590800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*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1012825" y="4423153"/>
            <a:ext cx="7346950" cy="15170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dirty="0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Supplemental Figure 1. Immunization with </a:t>
            </a:r>
            <a:r>
              <a:rPr lang="en-US" sz="1200" dirty="0" err="1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LepVax</a:t>
            </a:r>
            <a:r>
              <a:rPr lang="en-US" sz="1200" dirty="0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 reduces </a:t>
            </a:r>
            <a:r>
              <a:rPr lang="en-US" sz="1200" i="1" dirty="0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M. </a:t>
            </a:r>
            <a:r>
              <a:rPr lang="en-US" sz="1200" i="1" dirty="0" err="1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leprae</a:t>
            </a:r>
            <a:r>
              <a:rPr lang="en-US" sz="1200" dirty="0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 burden. Mice were injected subcutaneously with GLA-SE alone or </a:t>
            </a:r>
            <a:r>
              <a:rPr lang="en-US" sz="1200" dirty="0" err="1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LepVax</a:t>
            </a:r>
            <a:r>
              <a:rPr lang="en-US" sz="1200" dirty="0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 (</a:t>
            </a:r>
            <a:r>
              <a:rPr lang="en-US" sz="1200" dirty="0">
                <a:latin typeface="Calibri" panose="020F0502020204030204" pitchFamily="34" charset="0"/>
                <a:ea typeface="MS Mincho"/>
              </a:rPr>
              <a:t>LEP-F1+GLA-SE</a:t>
            </a:r>
            <a:r>
              <a:rPr lang="en-US" sz="1200" dirty="0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) at biweekly intervals, for a total of 3 immunizations. One month after the last immunization mice were infected with 1 x 10</a:t>
            </a:r>
            <a:r>
              <a:rPr lang="en-US" sz="1200" baseline="30000" dirty="0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4</a:t>
            </a:r>
            <a:r>
              <a:rPr lang="en-US" sz="1200" dirty="0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M. </a:t>
            </a:r>
            <a:r>
              <a:rPr lang="en-US" sz="1200" i="1" dirty="0" err="1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leprae</a:t>
            </a:r>
            <a:r>
              <a:rPr lang="en-US" sz="1200" dirty="0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 in each foot, and bacterial burdens determined 12 months later. Results are shown as mean and </a:t>
            </a:r>
            <a:r>
              <a:rPr lang="en-US" sz="1200" dirty="0" err="1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s.e.m</a:t>
            </a:r>
            <a:r>
              <a:rPr lang="en-US" sz="1200" dirty="0"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. n = 6 per </a:t>
            </a:r>
            <a:r>
              <a:rPr lang="en-US" sz="1200" dirty="0">
                <a:latin typeface="Calibri" panose="020F0502020204030204" pitchFamily="34" charset="0"/>
                <a:ea typeface="MS Mincho"/>
              </a:rPr>
              <a:t>group. **= </a:t>
            </a:r>
            <a:r>
              <a:rPr lang="en-US" sz="1200" i="1" dirty="0">
                <a:latin typeface="Calibri" panose="020F0502020204030204" pitchFamily="34" charset="0"/>
                <a:ea typeface="MS Mincho"/>
              </a:rPr>
              <a:t>p</a:t>
            </a:r>
            <a:r>
              <a:rPr lang="en-US" sz="1200" dirty="0">
                <a:latin typeface="Calibri" panose="020F0502020204030204" pitchFamily="34" charset="0"/>
                <a:ea typeface="MS Mincho"/>
              </a:rPr>
              <a:t>-value &lt; 0.01.</a:t>
            </a:r>
            <a:endParaRPr lang="en-US" sz="1200" dirty="0">
              <a:latin typeface="Times New Roman" panose="02020603050405020304" pitchFamily="18" charset="0"/>
              <a:ea typeface="MS Mincho"/>
            </a:endParaRPr>
          </a:p>
        </p:txBody>
      </p:sp>
    </p:spTree>
    <p:extLst>
      <p:ext uri="{BB962C8B-B14F-4D97-AF65-F5344CB8AC3E}">
        <p14:creationId xmlns:p14="http://schemas.microsoft.com/office/powerpoint/2010/main" val="3115952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586</TotalTime>
  <Words>90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MS Mincho</vt:lpstr>
      <vt:lpstr>Times New Roman</vt:lpstr>
      <vt:lpstr>Office Theme</vt:lpstr>
      <vt:lpstr>Prism 7</vt:lpstr>
      <vt:lpstr>PowerPoint Presentation</vt:lpstr>
    </vt:vector>
  </TitlesOfParts>
  <Company>DHHS\HRSA\OI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istrator</dc:creator>
  <cp:lastModifiedBy>Malcolm Duthie</cp:lastModifiedBy>
  <cp:revision>137</cp:revision>
  <dcterms:created xsi:type="dcterms:W3CDTF">2012-06-29T22:34:20Z</dcterms:created>
  <dcterms:modified xsi:type="dcterms:W3CDTF">2018-02-17T03:04:04Z</dcterms:modified>
</cp:coreProperties>
</file>